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88163" cy="10020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6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32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7668718706246215E-2"/>
          <c:y val="5.3912219305920092E-2"/>
          <c:w val="0.92794071722095472"/>
          <c:h val="0.63661891221930589"/>
        </c:manualLayout>
      </c:layout>
      <c:barChart>
        <c:barDir val="col"/>
        <c:grouping val="clustered"/>
        <c:varyColors val="0"/>
        <c:ser>
          <c:idx val="0"/>
          <c:order val="0"/>
          <c:tx>
            <c:v>endo fine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877-4480-AE5E-7DC18556E272}"/>
              </c:ext>
            </c:extLst>
          </c:dPt>
          <c:cat>
            <c:strRef>
              <c:f>'All weekly conc.'!$A$2:$A$78</c:f>
              <c:strCache>
                <c:ptCount val="77"/>
                <c:pt idx="0">
                  <c:v>1st week, Sep.,2014</c:v>
                </c:pt>
                <c:pt idx="1">
                  <c:v>2nd week</c:v>
                </c:pt>
                <c:pt idx="2">
                  <c:v>3rd week</c:v>
                </c:pt>
                <c:pt idx="3">
                  <c:v>4th week</c:v>
                </c:pt>
                <c:pt idx="4">
                  <c:v>1st week, Oct.</c:v>
                </c:pt>
                <c:pt idx="5">
                  <c:v>2nd week</c:v>
                </c:pt>
                <c:pt idx="6">
                  <c:v>1st week, Nov.</c:v>
                </c:pt>
                <c:pt idx="7">
                  <c:v>2nd week</c:v>
                </c:pt>
                <c:pt idx="8">
                  <c:v>3rd week</c:v>
                </c:pt>
                <c:pt idx="9">
                  <c:v>4th week</c:v>
                </c:pt>
                <c:pt idx="10">
                  <c:v>1st week, Dec.</c:v>
                </c:pt>
                <c:pt idx="11">
                  <c:v>2nd week</c:v>
                </c:pt>
                <c:pt idx="12">
                  <c:v>3rd week</c:v>
                </c:pt>
                <c:pt idx="13">
                  <c:v>4th week</c:v>
                </c:pt>
                <c:pt idx="14">
                  <c:v>1st week, Jan., 2015</c:v>
                </c:pt>
                <c:pt idx="15">
                  <c:v>2nd week</c:v>
                </c:pt>
                <c:pt idx="16">
                  <c:v>3rd week</c:v>
                </c:pt>
                <c:pt idx="17">
                  <c:v>1st week, Feb.</c:v>
                </c:pt>
                <c:pt idx="18">
                  <c:v>2nd week</c:v>
                </c:pt>
                <c:pt idx="19">
                  <c:v>3rd week</c:v>
                </c:pt>
                <c:pt idx="20">
                  <c:v>4th week</c:v>
                </c:pt>
                <c:pt idx="21">
                  <c:v>1st week, Mar.</c:v>
                </c:pt>
                <c:pt idx="22">
                  <c:v>2nd week</c:v>
                </c:pt>
                <c:pt idx="23">
                  <c:v>3rd week</c:v>
                </c:pt>
                <c:pt idx="24">
                  <c:v>4th week</c:v>
                </c:pt>
                <c:pt idx="25">
                  <c:v>1st week, Apr.</c:v>
                </c:pt>
                <c:pt idx="26">
                  <c:v>2nd week</c:v>
                </c:pt>
                <c:pt idx="27">
                  <c:v>3rd week</c:v>
                </c:pt>
                <c:pt idx="28">
                  <c:v>4th week</c:v>
                </c:pt>
                <c:pt idx="29">
                  <c:v>1st week, May</c:v>
                </c:pt>
                <c:pt idx="30">
                  <c:v>2nd week</c:v>
                </c:pt>
                <c:pt idx="31">
                  <c:v>3rd week</c:v>
                </c:pt>
                <c:pt idx="32">
                  <c:v>1st week, Jun.</c:v>
                </c:pt>
                <c:pt idx="33">
                  <c:v>2nd week</c:v>
                </c:pt>
                <c:pt idx="34">
                  <c:v>3rd week</c:v>
                </c:pt>
                <c:pt idx="35">
                  <c:v>4th week</c:v>
                </c:pt>
                <c:pt idx="36">
                  <c:v>1st week, Jul.</c:v>
                </c:pt>
                <c:pt idx="37">
                  <c:v>2nd week</c:v>
                </c:pt>
                <c:pt idx="38">
                  <c:v>3rd week</c:v>
                </c:pt>
                <c:pt idx="39">
                  <c:v>4th week</c:v>
                </c:pt>
                <c:pt idx="40">
                  <c:v>1st week, Aug.</c:v>
                </c:pt>
                <c:pt idx="41">
                  <c:v>2nd week</c:v>
                </c:pt>
                <c:pt idx="42">
                  <c:v>3rd week</c:v>
                </c:pt>
                <c:pt idx="43">
                  <c:v>4th week</c:v>
                </c:pt>
                <c:pt idx="44">
                  <c:v>1st week, Sep.</c:v>
                </c:pt>
                <c:pt idx="45">
                  <c:v>2nd week</c:v>
                </c:pt>
                <c:pt idx="46">
                  <c:v>3rd week</c:v>
                </c:pt>
                <c:pt idx="47">
                  <c:v>1st week, Oct.</c:v>
                </c:pt>
                <c:pt idx="48">
                  <c:v>2nd week</c:v>
                </c:pt>
                <c:pt idx="49">
                  <c:v>3rd week</c:v>
                </c:pt>
                <c:pt idx="50">
                  <c:v>4th week</c:v>
                </c:pt>
                <c:pt idx="51">
                  <c:v>1st week, Nov.</c:v>
                </c:pt>
                <c:pt idx="52">
                  <c:v>2nd week</c:v>
                </c:pt>
                <c:pt idx="53">
                  <c:v>3rd week</c:v>
                </c:pt>
                <c:pt idx="54">
                  <c:v>4th week</c:v>
                </c:pt>
                <c:pt idx="55">
                  <c:v>1st week, Dec.</c:v>
                </c:pt>
                <c:pt idx="56">
                  <c:v>2nd week</c:v>
                </c:pt>
                <c:pt idx="57">
                  <c:v>3rd week</c:v>
                </c:pt>
                <c:pt idx="58">
                  <c:v>1st week, Jan., 2016</c:v>
                </c:pt>
                <c:pt idx="59">
                  <c:v>2nd week</c:v>
                </c:pt>
                <c:pt idx="60">
                  <c:v>3rd week</c:v>
                </c:pt>
                <c:pt idx="61">
                  <c:v>4th week</c:v>
                </c:pt>
                <c:pt idx="62">
                  <c:v>1st week, Feb.</c:v>
                </c:pt>
                <c:pt idx="63">
                  <c:v>2nd week</c:v>
                </c:pt>
                <c:pt idx="64">
                  <c:v>3rd week</c:v>
                </c:pt>
                <c:pt idx="65">
                  <c:v>4th week</c:v>
                </c:pt>
                <c:pt idx="66">
                  <c:v>1st week, Mar.</c:v>
                </c:pt>
                <c:pt idx="67">
                  <c:v>2nd week</c:v>
                </c:pt>
                <c:pt idx="68">
                  <c:v>3rd week</c:v>
                </c:pt>
                <c:pt idx="69">
                  <c:v>4th week</c:v>
                </c:pt>
                <c:pt idx="70">
                  <c:v>1st week, Apr.</c:v>
                </c:pt>
                <c:pt idx="71">
                  <c:v>2nd week</c:v>
                </c:pt>
                <c:pt idx="72">
                  <c:v>3rd week</c:v>
                </c:pt>
                <c:pt idx="73">
                  <c:v>4th week</c:v>
                </c:pt>
                <c:pt idx="74">
                  <c:v>1st week, May</c:v>
                </c:pt>
                <c:pt idx="75">
                  <c:v>2nd week</c:v>
                </c:pt>
                <c:pt idx="76">
                  <c:v>3rd week</c:v>
                </c:pt>
              </c:strCache>
            </c:strRef>
          </c:cat>
          <c:val>
            <c:numRef>
              <c:f>'All weekly conc.'!$C$2:$C$78</c:f>
              <c:numCache>
                <c:formatCode>General</c:formatCode>
                <c:ptCount val="77"/>
                <c:pt idx="0">
                  <c:v>1.8982807198555526E-3</c:v>
                </c:pt>
                <c:pt idx="1">
                  <c:v>2.3017480505565587E-3</c:v>
                </c:pt>
                <c:pt idx="2">
                  <c:v>1.2785284430246633E-2</c:v>
                </c:pt>
                <c:pt idx="3">
                  <c:v>2.1430068056905891E-3</c:v>
                </c:pt>
                <c:pt idx="4">
                  <c:v>1.6733972896287629E-3</c:v>
                </c:pt>
                <c:pt idx="5">
                  <c:v>3.3798656719379355E-3</c:v>
                </c:pt>
                <c:pt idx="6">
                  <c:v>1.2567015218555924E-3</c:v>
                </c:pt>
                <c:pt idx="7">
                  <c:v>3.5417369392249853E-3</c:v>
                </c:pt>
                <c:pt idx="8">
                  <c:v>1.2401039703168716E-3</c:v>
                </c:pt>
                <c:pt idx="9">
                  <c:v>8.7969106529891476E-4</c:v>
                </c:pt>
                <c:pt idx="10">
                  <c:v>1.2104019921030178E-3</c:v>
                </c:pt>
                <c:pt idx="11">
                  <c:v>1.9710371237524555E-3</c:v>
                </c:pt>
                <c:pt idx="12">
                  <c:v>8.0693466140201197E-4</c:v>
                </c:pt>
                <c:pt idx="13">
                  <c:v>4.2992420484533426E-4</c:v>
                </c:pt>
                <c:pt idx="14">
                  <c:v>3.1086518715463447E-4</c:v>
                </c:pt>
                <c:pt idx="15">
                  <c:v>1.1905593364947717E-4</c:v>
                </c:pt>
                <c:pt idx="16">
                  <c:v>3.1086827119585706E-4</c:v>
                </c:pt>
                <c:pt idx="17">
                  <c:v>6.0189388678346788E-4</c:v>
                </c:pt>
                <c:pt idx="18">
                  <c:v>1.2633157403916747E-3</c:v>
                </c:pt>
                <c:pt idx="19">
                  <c:v>2.976398341236929E-4</c:v>
                </c:pt>
                <c:pt idx="20">
                  <c:v>4.0346733070100599E-4</c:v>
                </c:pt>
                <c:pt idx="21">
                  <c:v>5.7543701263913967E-4</c:v>
                </c:pt>
                <c:pt idx="22">
                  <c:v>6.5480763507212443E-4</c:v>
                </c:pt>
                <c:pt idx="23">
                  <c:v>2.2223774281235741E-3</c:v>
                </c:pt>
                <c:pt idx="24">
                  <c:v>3.8362467509275985E-4</c:v>
                </c:pt>
                <c:pt idx="25">
                  <c:v>1.1707166808865256E-3</c:v>
                </c:pt>
                <c:pt idx="26">
                  <c:v>1.2434730847834283E-3</c:v>
                </c:pt>
                <c:pt idx="27">
                  <c:v>3.9553026845770747E-3</c:v>
                </c:pt>
                <c:pt idx="28">
                  <c:v>2.447260858350364E-3</c:v>
                </c:pt>
                <c:pt idx="29">
                  <c:v>1.5477271374432036E-3</c:v>
                </c:pt>
                <c:pt idx="30">
                  <c:v>3.8362467509275985E-4</c:v>
                </c:pt>
                <c:pt idx="31">
                  <c:v>7.8246205281850834E-3</c:v>
                </c:pt>
                <c:pt idx="32">
                  <c:v>8.0032044286592989E-4</c:v>
                </c:pt>
                <c:pt idx="33">
                  <c:v>2.1760778983709993E-3</c:v>
                </c:pt>
                <c:pt idx="34">
                  <c:v>3.4393936387626742E-4</c:v>
                </c:pt>
                <c:pt idx="35">
                  <c:v>2.4472608583503641E-4</c:v>
                </c:pt>
                <c:pt idx="36">
                  <c:v>3.3071092680410332E-5</c:v>
                </c:pt>
                <c:pt idx="37">
                  <c:v>2.8555697008274985E-3</c:v>
                </c:pt>
                <c:pt idx="38">
                  <c:v>3.1748248973193915E-4</c:v>
                </c:pt>
                <c:pt idx="39">
                  <c:v>1.5212702632988749E-4</c:v>
                </c:pt>
                <c:pt idx="40">
                  <c:v>3.3071092680410325E-4</c:v>
                </c:pt>
                <c:pt idx="41">
                  <c:v>2.1165499315462609E-4</c:v>
                </c:pt>
                <c:pt idx="42">
                  <c:v>3.3732514534018534E-4</c:v>
                </c:pt>
                <c:pt idx="43">
                  <c:v>1.6270977598761881E-3</c:v>
                </c:pt>
                <c:pt idx="44">
                  <c:v>1.9445802496081274E-3</c:v>
                </c:pt>
                <c:pt idx="45">
                  <c:v>3.8693178436080078E-3</c:v>
                </c:pt>
                <c:pt idx="46">
                  <c:v>2.447260858350364E-3</c:v>
                </c:pt>
                <c:pt idx="47">
                  <c:v>4.9408212464533028E-3</c:v>
                </c:pt>
                <c:pt idx="48">
                  <c:v>6.9515436814222504E-3</c:v>
                </c:pt>
                <c:pt idx="49">
                  <c:v>2.6523016329689079E-3</c:v>
                </c:pt>
                <c:pt idx="50">
                  <c:v>4.0545159626183061E-3</c:v>
                </c:pt>
                <c:pt idx="51">
                  <c:v>2.4472608583503641E-4</c:v>
                </c:pt>
                <c:pt idx="52">
                  <c:v>5.6220857556697561E-4</c:v>
                </c:pt>
                <c:pt idx="53">
                  <c:v>1.005361217484474E-3</c:v>
                </c:pt>
                <c:pt idx="54">
                  <c:v>4.2330998630925218E-4</c:v>
                </c:pt>
                <c:pt idx="55">
                  <c:v>1.4154287244913146E-3</c:v>
                </c:pt>
                <c:pt idx="56">
                  <c:v>4.7622373459790866E-4</c:v>
                </c:pt>
                <c:pt idx="57">
                  <c:v>2.0504077461854403E-4</c:v>
                </c:pt>
                <c:pt idx="58">
                  <c:v>1.1574882438143614E-3</c:v>
                </c:pt>
                <c:pt idx="59">
                  <c:v>7.6062758559112696E-4</c:v>
                </c:pt>
                <c:pt idx="60">
                  <c:v>1.2897726145360028E-3</c:v>
                </c:pt>
                <c:pt idx="61">
                  <c:v>8.99533720907161E-4</c:v>
                </c:pt>
                <c:pt idx="62">
                  <c:v>1.0071413790249152E-3</c:v>
                </c:pt>
                <c:pt idx="63">
                  <c:v>6.8126450921645275E-4</c:v>
                </c:pt>
                <c:pt idx="64">
                  <c:v>1.322843707216413E-3</c:v>
                </c:pt>
                <c:pt idx="65">
                  <c:v>2.0570219647215223E-3</c:v>
                </c:pt>
                <c:pt idx="66">
                  <c:v>9.987469989483919E-4</c:v>
                </c:pt>
                <c:pt idx="67">
                  <c:v>1.1905593364947716E-3</c:v>
                </c:pt>
                <c:pt idx="68">
                  <c:v>9.1739211095458253E-3</c:v>
                </c:pt>
                <c:pt idx="69">
                  <c:v>4.2330998630925225E-3</c:v>
                </c:pt>
                <c:pt idx="70">
                  <c:v>2.3282049247008866E-3</c:v>
                </c:pt>
                <c:pt idx="71">
                  <c:v>1.1641024623504433E-3</c:v>
                </c:pt>
                <c:pt idx="72">
                  <c:v>1.6998541637730908E-3</c:v>
                </c:pt>
                <c:pt idx="73">
                  <c:v>2.2356058651957383E-3</c:v>
                </c:pt>
                <c:pt idx="74">
                  <c:v>3.2210924711554684E-3</c:v>
                </c:pt>
                <c:pt idx="75">
                  <c:v>6.5546905692573272E-3</c:v>
                </c:pt>
                <c:pt idx="76">
                  <c:v>2.943327248556519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5A0-4B64-966E-427E43424D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7696968"/>
        <c:axId val="287696184"/>
      </c:barChart>
      <c:catAx>
        <c:axId val="2876969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87696184"/>
        <c:crosses val="autoZero"/>
        <c:auto val="1"/>
        <c:lblAlgn val="ctr"/>
        <c:lblOffset val="100"/>
        <c:noMultiLvlLbl val="0"/>
      </c:catAx>
      <c:valAx>
        <c:axId val="2876961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87696968"/>
        <c:crosses val="autoZero"/>
        <c:crossBetween val="between"/>
        <c:majorUnit val="4.000000000000001E-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4032735267083696E-2"/>
          <c:y val="5.3912219305920092E-2"/>
          <c:w val="0.90935116387807957"/>
          <c:h val="0.63393372703412076"/>
        </c:manualLayout>
      </c:layout>
      <c:barChart>
        <c:barDir val="col"/>
        <c:grouping val="clustered"/>
        <c:varyColors val="0"/>
        <c:ser>
          <c:idx val="0"/>
          <c:order val="0"/>
          <c:tx>
            <c:v>endo coarse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All weekly conc.'!$A$2:$A$78</c:f>
              <c:strCache>
                <c:ptCount val="77"/>
                <c:pt idx="0">
                  <c:v>1st week, Sep.,2014</c:v>
                </c:pt>
                <c:pt idx="1">
                  <c:v>2nd week</c:v>
                </c:pt>
                <c:pt idx="2">
                  <c:v>3rd week</c:v>
                </c:pt>
                <c:pt idx="3">
                  <c:v>4th week</c:v>
                </c:pt>
                <c:pt idx="4">
                  <c:v>1st week, Oct.</c:v>
                </c:pt>
                <c:pt idx="5">
                  <c:v>2nd week</c:v>
                </c:pt>
                <c:pt idx="6">
                  <c:v>1st week, Nov.</c:v>
                </c:pt>
                <c:pt idx="7">
                  <c:v>2nd week</c:v>
                </c:pt>
                <c:pt idx="8">
                  <c:v>3rd week</c:v>
                </c:pt>
                <c:pt idx="9">
                  <c:v>4th week</c:v>
                </c:pt>
                <c:pt idx="10">
                  <c:v>1st week, Dec.</c:v>
                </c:pt>
                <c:pt idx="11">
                  <c:v>2nd week</c:v>
                </c:pt>
                <c:pt idx="12">
                  <c:v>3rd week</c:v>
                </c:pt>
                <c:pt idx="13">
                  <c:v>4th week</c:v>
                </c:pt>
                <c:pt idx="14">
                  <c:v>1st week, Jan., 2015</c:v>
                </c:pt>
                <c:pt idx="15">
                  <c:v>2nd week</c:v>
                </c:pt>
                <c:pt idx="16">
                  <c:v>3rd week</c:v>
                </c:pt>
                <c:pt idx="17">
                  <c:v>1st week, Feb.</c:v>
                </c:pt>
                <c:pt idx="18">
                  <c:v>2nd week</c:v>
                </c:pt>
                <c:pt idx="19">
                  <c:v>3rd week</c:v>
                </c:pt>
                <c:pt idx="20">
                  <c:v>4th week</c:v>
                </c:pt>
                <c:pt idx="21">
                  <c:v>1st week, Mar.</c:v>
                </c:pt>
                <c:pt idx="22">
                  <c:v>2nd week</c:v>
                </c:pt>
                <c:pt idx="23">
                  <c:v>3rd week</c:v>
                </c:pt>
                <c:pt idx="24">
                  <c:v>4th week</c:v>
                </c:pt>
                <c:pt idx="25">
                  <c:v>1st week, Apr.</c:v>
                </c:pt>
                <c:pt idx="26">
                  <c:v>2nd week</c:v>
                </c:pt>
                <c:pt idx="27">
                  <c:v>3rd week</c:v>
                </c:pt>
                <c:pt idx="28">
                  <c:v>4th week</c:v>
                </c:pt>
                <c:pt idx="29">
                  <c:v>1st week, May</c:v>
                </c:pt>
                <c:pt idx="30">
                  <c:v>2nd week</c:v>
                </c:pt>
                <c:pt idx="31">
                  <c:v>3rd week</c:v>
                </c:pt>
                <c:pt idx="32">
                  <c:v>1st week, Jun.</c:v>
                </c:pt>
                <c:pt idx="33">
                  <c:v>2nd week</c:v>
                </c:pt>
                <c:pt idx="34">
                  <c:v>3rd week</c:v>
                </c:pt>
                <c:pt idx="35">
                  <c:v>4th week</c:v>
                </c:pt>
                <c:pt idx="36">
                  <c:v>1st week, Jul.</c:v>
                </c:pt>
                <c:pt idx="37">
                  <c:v>2nd week</c:v>
                </c:pt>
                <c:pt idx="38">
                  <c:v>3rd week</c:v>
                </c:pt>
                <c:pt idx="39">
                  <c:v>4th week</c:v>
                </c:pt>
                <c:pt idx="40">
                  <c:v>1st week, Aug.</c:v>
                </c:pt>
                <c:pt idx="41">
                  <c:v>2nd week</c:v>
                </c:pt>
                <c:pt idx="42">
                  <c:v>3rd week</c:v>
                </c:pt>
                <c:pt idx="43">
                  <c:v>4th week</c:v>
                </c:pt>
                <c:pt idx="44">
                  <c:v>1st week, Sep.</c:v>
                </c:pt>
                <c:pt idx="45">
                  <c:v>2nd week</c:v>
                </c:pt>
                <c:pt idx="46">
                  <c:v>3rd week</c:v>
                </c:pt>
                <c:pt idx="47">
                  <c:v>1st week, Oct.</c:v>
                </c:pt>
                <c:pt idx="48">
                  <c:v>2nd week</c:v>
                </c:pt>
                <c:pt idx="49">
                  <c:v>3rd week</c:v>
                </c:pt>
                <c:pt idx="50">
                  <c:v>4th week</c:v>
                </c:pt>
                <c:pt idx="51">
                  <c:v>1st week, Nov.</c:v>
                </c:pt>
                <c:pt idx="52">
                  <c:v>2nd week</c:v>
                </c:pt>
                <c:pt idx="53">
                  <c:v>3rd week</c:v>
                </c:pt>
                <c:pt idx="54">
                  <c:v>4th week</c:v>
                </c:pt>
                <c:pt idx="55">
                  <c:v>1st week, Dec.</c:v>
                </c:pt>
                <c:pt idx="56">
                  <c:v>2nd week</c:v>
                </c:pt>
                <c:pt idx="57">
                  <c:v>3rd week</c:v>
                </c:pt>
                <c:pt idx="58">
                  <c:v>1st week, Jan., 2016</c:v>
                </c:pt>
                <c:pt idx="59">
                  <c:v>2nd week</c:v>
                </c:pt>
                <c:pt idx="60">
                  <c:v>3rd week</c:v>
                </c:pt>
                <c:pt idx="61">
                  <c:v>4th week</c:v>
                </c:pt>
                <c:pt idx="62">
                  <c:v>1st week, Feb.</c:v>
                </c:pt>
                <c:pt idx="63">
                  <c:v>2nd week</c:v>
                </c:pt>
                <c:pt idx="64">
                  <c:v>3rd week</c:v>
                </c:pt>
                <c:pt idx="65">
                  <c:v>4th week</c:v>
                </c:pt>
                <c:pt idx="66">
                  <c:v>1st week, Mar.</c:v>
                </c:pt>
                <c:pt idx="67">
                  <c:v>2nd week</c:v>
                </c:pt>
                <c:pt idx="68">
                  <c:v>3rd week</c:v>
                </c:pt>
                <c:pt idx="69">
                  <c:v>4th week</c:v>
                </c:pt>
                <c:pt idx="70">
                  <c:v>1st week, Apr.</c:v>
                </c:pt>
                <c:pt idx="71">
                  <c:v>2nd week</c:v>
                </c:pt>
                <c:pt idx="72">
                  <c:v>3rd week</c:v>
                </c:pt>
                <c:pt idx="73">
                  <c:v>4th week</c:v>
                </c:pt>
                <c:pt idx="74">
                  <c:v>1st week, May</c:v>
                </c:pt>
                <c:pt idx="75">
                  <c:v>2nd week</c:v>
                </c:pt>
                <c:pt idx="76">
                  <c:v>3rd week</c:v>
                </c:pt>
              </c:strCache>
            </c:strRef>
          </c:cat>
          <c:val>
            <c:numRef>
              <c:f>'All weekly conc.'!$O$2:$O$78</c:f>
              <c:numCache>
                <c:formatCode>0.0000_);[Red]\(0.0000\)</c:formatCode>
                <c:ptCount val="77"/>
                <c:pt idx="0">
                  <c:v>2.9215003273874482E-2</c:v>
                </c:pt>
                <c:pt idx="1">
                  <c:v>6.7795739994841167E-3</c:v>
                </c:pt>
                <c:pt idx="2">
                  <c:v>1.9885648028730728E-2</c:v>
                </c:pt>
                <c:pt idx="3">
                  <c:v>1.5563256215401102E-2</c:v>
                </c:pt>
                <c:pt idx="4">
                  <c:v>5.608857318597592E-3</c:v>
                </c:pt>
                <c:pt idx="5">
                  <c:v>4.9275928093811391E-3</c:v>
                </c:pt>
                <c:pt idx="6">
                  <c:v>4.9871207762058776E-3</c:v>
                </c:pt>
                <c:pt idx="7">
                  <c:v>7.0937493799480148E-3</c:v>
                </c:pt>
                <c:pt idx="8">
                  <c:v>2.9762495287604914E-3</c:v>
                </c:pt>
                <c:pt idx="9">
                  <c:v>1.1376455882061152E-3</c:v>
                </c:pt>
                <c:pt idx="10">
                  <c:v>1.2897726145360028E-3</c:v>
                </c:pt>
                <c:pt idx="11">
                  <c:v>3.3004950495049506E-3</c:v>
                </c:pt>
                <c:pt idx="12">
                  <c:v>1.5477271374432036E-3</c:v>
                </c:pt>
                <c:pt idx="13">
                  <c:v>1.1310313696700333E-3</c:v>
                </c:pt>
                <c:pt idx="14">
                  <c:v>1.4253499538685898E-3</c:v>
                </c:pt>
                <c:pt idx="15">
                  <c:v>3.7701045655667777E-4</c:v>
                </c:pt>
                <c:pt idx="16">
                  <c:v>1.0979602769896229E-3</c:v>
                </c:pt>
                <c:pt idx="17">
                  <c:v>1.2732370681957977E-3</c:v>
                </c:pt>
                <c:pt idx="18">
                  <c:v>1.4154427667215622E-3</c:v>
                </c:pt>
                <c:pt idx="19">
                  <c:v>9.1937637651540714E-4</c:v>
                </c:pt>
                <c:pt idx="20">
                  <c:v>2.1363925871545069E-3</c:v>
                </c:pt>
                <c:pt idx="21" formatCode="0.0000">
                  <c:v>9.0284083017520215E-4</c:v>
                </c:pt>
                <c:pt idx="22" formatCode="0.0000">
                  <c:v>1.6800115081648448E-3</c:v>
                </c:pt>
                <c:pt idx="23" formatCode="0.0000">
                  <c:v>4.130579475783251E-3</c:v>
                </c:pt>
                <c:pt idx="24" formatCode="0.0000">
                  <c:v>1.1310313696700333E-3</c:v>
                </c:pt>
                <c:pt idx="25" formatCode="0.0000">
                  <c:v>5.5923217722573864E-3</c:v>
                </c:pt>
                <c:pt idx="26" formatCode="0.0000">
                  <c:v>4.4414477469791065E-3</c:v>
                </c:pt>
                <c:pt idx="27" formatCode="0.0000">
                  <c:v>9.7361296851127994E-3</c:v>
                </c:pt>
                <c:pt idx="28" formatCode="0.0000">
                  <c:v>2.7845860036905495E-3</c:v>
                </c:pt>
                <c:pt idx="29" formatCode="0.0000">
                  <c:v>5.767598563463561E-3</c:v>
                </c:pt>
                <c:pt idx="30" formatCode="0.0000">
                  <c:v>2.0735575110617274E-3</c:v>
                </c:pt>
                <c:pt idx="31" formatCode="0.0000">
                  <c:v>4.8316866406079495E-3</c:v>
                </c:pt>
                <c:pt idx="32" formatCode="0.0000">
                  <c:v>4.5241254786801332E-3</c:v>
                </c:pt>
                <c:pt idx="33" formatCode="0.0000">
                  <c:v>1.0767947776741602E-2</c:v>
                </c:pt>
                <c:pt idx="34" formatCode="0.0000">
                  <c:v>2.3447404710410921E-3</c:v>
                </c:pt>
                <c:pt idx="35" formatCode="0.0000">
                  <c:v>3.482386059247207E-3</c:v>
                </c:pt>
                <c:pt idx="36" formatCode="0.0000">
                  <c:v>1.0847318399174587E-3</c:v>
                </c:pt>
                <c:pt idx="37" formatCode="0.0000">
                  <c:v>9.5665181413112661E-3</c:v>
                </c:pt>
                <c:pt idx="38" formatCode="0.0000">
                  <c:v>1.1035823627452928E-2</c:v>
                </c:pt>
                <c:pt idx="39" formatCode="0.0000">
                  <c:v>1.0721648246989028E-2</c:v>
                </c:pt>
                <c:pt idx="40" formatCode="0.0000">
                  <c:v>7.9006840413500257E-3</c:v>
                </c:pt>
                <c:pt idx="41" formatCode="0.0000">
                  <c:v>4.1371936943193311E-3</c:v>
                </c:pt>
                <c:pt idx="42" formatCode="0.0000">
                  <c:v>8.4265144149685521E-3</c:v>
                </c:pt>
                <c:pt idx="43" formatCode="0.0000">
                  <c:v>1.7643427944998912E-2</c:v>
                </c:pt>
                <c:pt idx="44" formatCode="0.0000">
                  <c:v>1.4276790710133141E-2</c:v>
                </c:pt>
                <c:pt idx="45" formatCode="0.0000">
                  <c:v>1.3784031429195025E-2</c:v>
                </c:pt>
                <c:pt idx="46" formatCode="0.0000">
                  <c:v>1.2229690073215737E-2</c:v>
                </c:pt>
                <c:pt idx="47" formatCode="0.0000">
                  <c:v>8.9258879144427476E-3</c:v>
                </c:pt>
                <c:pt idx="48" formatCode="0.0000">
                  <c:v>8.8828954939582129E-3</c:v>
                </c:pt>
                <c:pt idx="49" formatCode="0.0000">
                  <c:v>5.5989359907934683E-3</c:v>
                </c:pt>
                <c:pt idx="50" formatCode="0.0000">
                  <c:v>1.0460386614813787E-2</c:v>
                </c:pt>
                <c:pt idx="51" formatCode="0.0000">
                  <c:v>1.6700901803607213E-3</c:v>
                </c:pt>
                <c:pt idx="52" formatCode="0.0000">
                  <c:v>3.3038021587729919E-3</c:v>
                </c:pt>
                <c:pt idx="53" formatCode="0.0000">
                  <c:v>1.9545015774122504E-3</c:v>
                </c:pt>
                <c:pt idx="54" formatCode="0.0000">
                  <c:v>6.3496497946387829E-4</c:v>
                </c:pt>
                <c:pt idx="55" formatCode="0.0000">
                  <c:v>2.2521190686415542E-3</c:v>
                </c:pt>
                <c:pt idx="56" formatCode="0.0000">
                  <c:v>2.1628494612988352E-3</c:v>
                </c:pt>
                <c:pt idx="57" formatCode="0.0000">
                  <c:v>1.3724503462370285E-3</c:v>
                </c:pt>
                <c:pt idx="58" formatCode="0.0000">
                  <c:v>1.3922930018452748E-3</c:v>
                </c:pt>
                <c:pt idx="59" formatCode="0.0000">
                  <c:v>1.3096022778003749E-3</c:v>
                </c:pt>
                <c:pt idx="60" formatCode="0.0000">
                  <c:v>1.7891461140101986E-3</c:v>
                </c:pt>
                <c:pt idx="61" formatCode="0.0000">
                  <c:v>1.1078816047937459E-3</c:v>
                </c:pt>
                <c:pt idx="62" formatCode="0.0000">
                  <c:v>1.2968669812101646E-3</c:v>
                </c:pt>
                <c:pt idx="63" formatCode="0.0000">
                  <c:v>2.0404864183813172E-3</c:v>
                </c:pt>
                <c:pt idx="64" formatCode="0.0000">
                  <c:v>1.9082020476596758E-3</c:v>
                </c:pt>
                <c:pt idx="65" formatCode="0.0000">
                  <c:v>1.6105622135359832E-3</c:v>
                </c:pt>
                <c:pt idx="66" formatCode="0.0000">
                  <c:v>2.8374997519792062E-3</c:v>
                </c:pt>
                <c:pt idx="67" formatCode="0.0000">
                  <c:v>1.8883593920514293E-3</c:v>
                </c:pt>
                <c:pt idx="68" formatCode="0.0000">
                  <c:v>6.3132715926903313E-3</c:v>
                </c:pt>
                <c:pt idx="69" formatCode="0.0000">
                  <c:v>7.0573711779995637E-3</c:v>
                </c:pt>
                <c:pt idx="70" formatCode="0.0000">
                  <c:v>3.1384466953709401E-3</c:v>
                </c:pt>
                <c:pt idx="71" formatCode="0.0000">
                  <c:v>2.0008011071648247E-3</c:v>
                </c:pt>
                <c:pt idx="72" formatCode="0.0000">
                  <c:v>1.6403261969483523E-3</c:v>
                </c:pt>
                <c:pt idx="73" formatCode="0.0000">
                  <c:v>5.374052560566678E-3</c:v>
                </c:pt>
                <c:pt idx="74" formatCode="0.0000">
                  <c:v>6.9977737874383685E-3</c:v>
                </c:pt>
                <c:pt idx="75" formatCode="0.0000">
                  <c:v>1.2011420861525032E-2</c:v>
                </c:pt>
                <c:pt idx="76" formatCode="0.0000">
                  <c:v>4.127272366515209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743-424F-A2BC-DAB88BF0C8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7695400"/>
        <c:axId val="287693440"/>
      </c:barChart>
      <c:catAx>
        <c:axId val="287695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87693440"/>
        <c:crosses val="autoZero"/>
        <c:auto val="1"/>
        <c:lblAlgn val="ctr"/>
        <c:lblOffset val="100"/>
        <c:noMultiLvlLbl val="0"/>
      </c:catAx>
      <c:valAx>
        <c:axId val="287693440"/>
        <c:scaling>
          <c:orientation val="minMax"/>
          <c:max val="4.0000000000000008E-2"/>
        </c:scaling>
        <c:delete val="0"/>
        <c:axPos val="l"/>
        <c:numFmt formatCode="@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87695400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r">
              <a:defRPr sz="1300"/>
            </a:lvl1pPr>
          </a:lstStyle>
          <a:p>
            <a:fld id="{3A701E97-2F4F-424D-9779-542B179354F3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90625" y="1252538"/>
            <a:ext cx="4506913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6" tIns="48308" rIns="96616" bIns="48308" rtlCol="0" anchor="ctr"/>
          <a:lstStyle/>
          <a:p>
            <a:endParaRPr lang="en-GB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2269"/>
            <a:ext cx="5510530" cy="3945493"/>
          </a:xfrm>
          <a:prstGeom prst="rect">
            <a:avLst/>
          </a:prstGeom>
        </p:spPr>
        <p:txBody>
          <a:bodyPr vert="horz" lIns="96616" tIns="48308" rIns="96616" bIns="48308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GB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r">
              <a:defRPr sz="1300"/>
            </a:lvl1pPr>
          </a:lstStyle>
          <a:p>
            <a:fld id="{1E42CB34-CF8D-40DE-9239-EB771D8D35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3300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190625" y="1252538"/>
            <a:ext cx="4506913" cy="338137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B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B1AE9E-4C91-422A-B887-87B95C3F927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42996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786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7141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4753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9280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7755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8963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1028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45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0106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9480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3322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F2900-81D2-47F5-9888-658CD8036BF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D085F6-3CFC-485D-9133-FE98AAF864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7572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/>
          <p:cNvSpPr/>
          <p:nvPr/>
        </p:nvSpPr>
        <p:spPr>
          <a:xfrm>
            <a:off x="92950" y="120238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ea typeface="HGS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114657" y="3119461"/>
            <a:ext cx="2936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正方形/長方形 24"/>
          <p:cNvSpPr/>
          <p:nvPr/>
        </p:nvSpPr>
        <p:spPr>
          <a:xfrm flipH="1">
            <a:off x="-65543" y="351801"/>
            <a:ext cx="74079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/</a:t>
            </a:r>
            <a:r>
              <a:rPr lang="en-US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</a:t>
            </a:r>
            <a:r>
              <a:rPr lang="en-US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GB" sz="83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831" kern="100" dirty="0">
              <a:solidFill>
                <a:prstClr val="black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6" name="正方形/長方形 25"/>
          <p:cNvSpPr/>
          <p:nvPr/>
        </p:nvSpPr>
        <p:spPr>
          <a:xfrm flipH="1">
            <a:off x="-46552" y="3369840"/>
            <a:ext cx="74079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l-GR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/</a:t>
            </a:r>
            <a:r>
              <a:rPr lang="en-US" sz="1000" kern="100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</a:t>
            </a:r>
            <a:r>
              <a:rPr lang="en-US" sz="1000" kern="10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GB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000" kern="100" dirty="0">
              <a:solidFill>
                <a:prstClr val="black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8" name="正方形/長方形 47"/>
          <p:cNvSpPr/>
          <p:nvPr/>
        </p:nvSpPr>
        <p:spPr>
          <a:xfrm>
            <a:off x="2037426" y="489037"/>
            <a:ext cx="60417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1</a:t>
            </a:r>
          </a:p>
        </p:txBody>
      </p:sp>
      <p:sp>
        <p:nvSpPr>
          <p:cNvPr id="49" name="正方形/長方形 48"/>
          <p:cNvSpPr/>
          <p:nvPr/>
        </p:nvSpPr>
        <p:spPr>
          <a:xfrm>
            <a:off x="923435" y="486611"/>
            <a:ext cx="67676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1</a:t>
            </a:r>
          </a:p>
        </p:txBody>
      </p:sp>
      <p:sp>
        <p:nvSpPr>
          <p:cNvPr id="50" name="正方形/長方形 49"/>
          <p:cNvSpPr/>
          <p:nvPr/>
        </p:nvSpPr>
        <p:spPr>
          <a:xfrm>
            <a:off x="3222824" y="487790"/>
            <a:ext cx="632303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1</a:t>
            </a:r>
          </a:p>
        </p:txBody>
      </p:sp>
      <p:sp>
        <p:nvSpPr>
          <p:cNvPr id="51" name="正方形/長方形 50"/>
          <p:cNvSpPr/>
          <p:nvPr/>
        </p:nvSpPr>
        <p:spPr>
          <a:xfrm>
            <a:off x="4462136" y="487786"/>
            <a:ext cx="624669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er</a:t>
            </a:r>
            <a:endParaRPr lang="en-GB" sz="9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52" name="正方形/長方形 51"/>
          <p:cNvSpPr/>
          <p:nvPr/>
        </p:nvSpPr>
        <p:spPr>
          <a:xfrm>
            <a:off x="5589616" y="487787"/>
            <a:ext cx="65878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2</a:t>
            </a:r>
          </a:p>
        </p:txBody>
      </p:sp>
      <p:sp>
        <p:nvSpPr>
          <p:cNvPr id="53" name="正方形/長方形 52"/>
          <p:cNvSpPr/>
          <p:nvPr/>
        </p:nvSpPr>
        <p:spPr>
          <a:xfrm>
            <a:off x="6818070" y="487792"/>
            <a:ext cx="69538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2</a:t>
            </a:r>
          </a:p>
        </p:txBody>
      </p:sp>
      <p:sp>
        <p:nvSpPr>
          <p:cNvPr id="54" name="正方形/長方形 53"/>
          <p:cNvSpPr/>
          <p:nvPr/>
        </p:nvSpPr>
        <p:spPr>
          <a:xfrm>
            <a:off x="7982137" y="489523"/>
            <a:ext cx="576343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2</a:t>
            </a:r>
          </a:p>
        </p:txBody>
      </p:sp>
      <p:sp>
        <p:nvSpPr>
          <p:cNvPr id="62" name="正方形/長方形 61"/>
          <p:cNvSpPr/>
          <p:nvPr/>
        </p:nvSpPr>
        <p:spPr>
          <a:xfrm>
            <a:off x="2024726" y="3489335"/>
            <a:ext cx="64227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1</a:t>
            </a:r>
          </a:p>
        </p:txBody>
      </p:sp>
      <p:sp>
        <p:nvSpPr>
          <p:cNvPr id="63" name="正方形/長方形 62"/>
          <p:cNvSpPr/>
          <p:nvPr/>
        </p:nvSpPr>
        <p:spPr>
          <a:xfrm>
            <a:off x="910735" y="3486909"/>
            <a:ext cx="67676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1</a:t>
            </a:r>
          </a:p>
        </p:txBody>
      </p:sp>
      <p:sp>
        <p:nvSpPr>
          <p:cNvPr id="64" name="正方形/長方形 63"/>
          <p:cNvSpPr/>
          <p:nvPr/>
        </p:nvSpPr>
        <p:spPr>
          <a:xfrm>
            <a:off x="3198973" y="3488088"/>
            <a:ext cx="632303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1</a:t>
            </a:r>
          </a:p>
        </p:txBody>
      </p:sp>
      <p:sp>
        <p:nvSpPr>
          <p:cNvPr id="65" name="正方形/長方形 64"/>
          <p:cNvSpPr/>
          <p:nvPr/>
        </p:nvSpPr>
        <p:spPr>
          <a:xfrm>
            <a:off x="4438285" y="3488084"/>
            <a:ext cx="624669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er</a:t>
            </a:r>
            <a:endParaRPr lang="en-GB" sz="9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66" name="正方形/長方形 65"/>
          <p:cNvSpPr/>
          <p:nvPr/>
        </p:nvSpPr>
        <p:spPr>
          <a:xfrm>
            <a:off x="5576916" y="3488085"/>
            <a:ext cx="67148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2</a:t>
            </a:r>
          </a:p>
        </p:txBody>
      </p:sp>
      <p:sp>
        <p:nvSpPr>
          <p:cNvPr id="67" name="正方形/長方形 66"/>
          <p:cNvSpPr/>
          <p:nvPr/>
        </p:nvSpPr>
        <p:spPr>
          <a:xfrm>
            <a:off x="6805370" y="3488090"/>
            <a:ext cx="69538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2</a:t>
            </a:r>
          </a:p>
        </p:txBody>
      </p:sp>
      <p:sp>
        <p:nvSpPr>
          <p:cNvPr id="68" name="正方形/長方形 67"/>
          <p:cNvSpPr/>
          <p:nvPr/>
        </p:nvSpPr>
        <p:spPr>
          <a:xfrm>
            <a:off x="7969437" y="3489821"/>
            <a:ext cx="576343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2</a:t>
            </a:r>
          </a:p>
        </p:txBody>
      </p:sp>
      <p:graphicFrame>
        <p:nvGraphicFramePr>
          <p:cNvPr id="38" name="グラフ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8237047"/>
              </p:ext>
            </p:extLst>
          </p:nvPr>
        </p:nvGraphicFramePr>
        <p:xfrm>
          <a:off x="89209" y="540834"/>
          <a:ext cx="887637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2" name="グラフ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1519333"/>
              </p:ext>
            </p:extLst>
          </p:nvPr>
        </p:nvGraphicFramePr>
        <p:xfrm>
          <a:off x="-1" y="3529362"/>
          <a:ext cx="906594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55" name="直線矢印コネクタ 54"/>
          <p:cNvCxnSpPr/>
          <p:nvPr/>
        </p:nvCxnSpPr>
        <p:spPr>
          <a:xfrm>
            <a:off x="1654629" y="684245"/>
            <a:ext cx="1171561" cy="7133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矢印コネクタ 68"/>
          <p:cNvCxnSpPr/>
          <p:nvPr/>
        </p:nvCxnSpPr>
        <p:spPr>
          <a:xfrm flipV="1">
            <a:off x="2829104" y="684245"/>
            <a:ext cx="1176839" cy="6374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矢印コネクタ 75"/>
          <p:cNvCxnSpPr/>
          <p:nvPr/>
        </p:nvCxnSpPr>
        <p:spPr>
          <a:xfrm flipV="1">
            <a:off x="4012467" y="686779"/>
            <a:ext cx="1280161" cy="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矢印コネクタ 76"/>
          <p:cNvCxnSpPr/>
          <p:nvPr/>
        </p:nvCxnSpPr>
        <p:spPr>
          <a:xfrm>
            <a:off x="5292628" y="686773"/>
            <a:ext cx="1182152" cy="3587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矢印コネクタ 77"/>
          <p:cNvCxnSpPr/>
          <p:nvPr/>
        </p:nvCxnSpPr>
        <p:spPr>
          <a:xfrm flipV="1">
            <a:off x="7638586" y="684245"/>
            <a:ext cx="1188173" cy="913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矢印コネクタ 78"/>
          <p:cNvCxnSpPr/>
          <p:nvPr/>
        </p:nvCxnSpPr>
        <p:spPr>
          <a:xfrm flipV="1">
            <a:off x="6475970" y="684245"/>
            <a:ext cx="1150250" cy="2534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矢印コネクタ 79"/>
          <p:cNvCxnSpPr/>
          <p:nvPr/>
        </p:nvCxnSpPr>
        <p:spPr>
          <a:xfrm>
            <a:off x="598751" y="683720"/>
            <a:ext cx="1057792" cy="3053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矢印コネクタ 81"/>
          <p:cNvCxnSpPr/>
          <p:nvPr/>
        </p:nvCxnSpPr>
        <p:spPr>
          <a:xfrm>
            <a:off x="2831607" y="3681651"/>
            <a:ext cx="1180556" cy="83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矢印コネクタ 82"/>
          <p:cNvCxnSpPr/>
          <p:nvPr/>
        </p:nvCxnSpPr>
        <p:spPr>
          <a:xfrm>
            <a:off x="4018384" y="3682482"/>
            <a:ext cx="1250302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矢印コネクタ 83"/>
          <p:cNvCxnSpPr/>
          <p:nvPr/>
        </p:nvCxnSpPr>
        <p:spPr>
          <a:xfrm>
            <a:off x="5277760" y="3682736"/>
            <a:ext cx="1182152" cy="3587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矢印コネクタ 84"/>
          <p:cNvCxnSpPr/>
          <p:nvPr/>
        </p:nvCxnSpPr>
        <p:spPr>
          <a:xfrm flipV="1">
            <a:off x="7638585" y="3675173"/>
            <a:ext cx="1189677" cy="4727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矢印コネクタ 85"/>
          <p:cNvCxnSpPr/>
          <p:nvPr/>
        </p:nvCxnSpPr>
        <p:spPr>
          <a:xfrm flipV="1">
            <a:off x="6461102" y="3679900"/>
            <a:ext cx="1166332" cy="2842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矢印コネクタ 86"/>
          <p:cNvCxnSpPr/>
          <p:nvPr/>
        </p:nvCxnSpPr>
        <p:spPr>
          <a:xfrm>
            <a:off x="588814" y="3668532"/>
            <a:ext cx="1057792" cy="3053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矢印コネクタ 88"/>
          <p:cNvCxnSpPr/>
          <p:nvPr/>
        </p:nvCxnSpPr>
        <p:spPr>
          <a:xfrm>
            <a:off x="1650380" y="3668751"/>
            <a:ext cx="1170879" cy="1115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F4221AD1-CD74-4F48-A7AE-58CA877EC1C7}"/>
              </a:ext>
            </a:extLst>
          </p:cNvPr>
          <p:cNvSpPr/>
          <p:nvPr/>
        </p:nvSpPr>
        <p:spPr>
          <a:xfrm>
            <a:off x="3921333" y="6511875"/>
            <a:ext cx="5252219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hammad Shahriar Khan </a:t>
            </a:r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</a:t>
            </a:r>
            <a:r>
              <a:rPr lang="en-GB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dditional file: Figure S3</a:t>
            </a:r>
            <a:endParaRPr lang="en-GB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2442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</TotalTime>
  <Words>52</Words>
  <Application>Microsoft Office PowerPoint</Application>
  <PresentationFormat>画面に合わせる (4:3)</PresentationFormat>
  <Paragraphs>2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HGPｺﾞｼｯｸE</vt:lpstr>
      <vt:lpstr>HGSｺﾞｼｯｸE</vt:lpstr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sei</dc:creator>
  <cp:lastModifiedBy>watanabe tetsushi</cp:lastModifiedBy>
  <cp:revision>30</cp:revision>
  <cp:lastPrinted>2018-06-11T10:56:59Z</cp:lastPrinted>
  <dcterms:created xsi:type="dcterms:W3CDTF">2018-05-24T05:22:49Z</dcterms:created>
  <dcterms:modified xsi:type="dcterms:W3CDTF">2018-08-01T03:19:50Z</dcterms:modified>
</cp:coreProperties>
</file>